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83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"/><Relationship Id="rId5" Type="http://schemas.openxmlformats.org/officeDocument/2006/relationships/image" Target="../media/image17.tif"/><Relationship Id="rId4" Type="http://schemas.openxmlformats.org/officeDocument/2006/relationships/image" Target="../media/image1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"/><Relationship Id="rId5" Type="http://schemas.openxmlformats.org/officeDocument/2006/relationships/image" Target="../media/image17.tif"/><Relationship Id="rId4" Type="http://schemas.openxmlformats.org/officeDocument/2006/relationships/image" Target="../media/image1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4DDE5A8-BD22-DE99-236E-14F25EB4E0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626" y="178839"/>
            <a:ext cx="3600000" cy="3600000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743D4A11-A6E9-FC4D-873A-DB69834AA47C}"/>
              </a:ext>
            </a:extLst>
          </p:cNvPr>
          <p:cNvSpPr/>
          <p:nvPr/>
        </p:nvSpPr>
        <p:spPr>
          <a:xfrm>
            <a:off x="861821" y="1745976"/>
            <a:ext cx="984143" cy="44170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8CB4797-8CC7-71B0-1849-E37A6D671F54}"/>
              </a:ext>
            </a:extLst>
          </p:cNvPr>
          <p:cNvSpPr txBox="1"/>
          <p:nvPr/>
        </p:nvSpPr>
        <p:spPr>
          <a:xfrm>
            <a:off x="1123763" y="4205087"/>
            <a:ext cx="1757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A-TAZ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23CF77E-09DB-8A3B-CFEC-1126A86F3E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57539" y="178839"/>
            <a:ext cx="2072640" cy="207264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708D051-406F-137E-3937-4513B8E93F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4712" y="178839"/>
            <a:ext cx="2072640" cy="207264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1AD6C055-EFF0-CA2C-09E1-D9947B9BBD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0701" y="178839"/>
            <a:ext cx="2072640" cy="207264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ABB1F1E-95C2-E08D-0CB6-370BA87F3BBE}"/>
              </a:ext>
            </a:extLst>
          </p:cNvPr>
          <p:cNvSpPr txBox="1"/>
          <p:nvPr/>
        </p:nvSpPr>
        <p:spPr>
          <a:xfrm>
            <a:off x="6096000" y="3244334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CC9928C-13B6-1CBD-6F7A-554AAEEDA5F4}"/>
              </a:ext>
            </a:extLst>
          </p:cNvPr>
          <p:cNvSpPr txBox="1"/>
          <p:nvPr/>
        </p:nvSpPr>
        <p:spPr>
          <a:xfrm>
            <a:off x="4843281" y="2378574"/>
            <a:ext cx="1317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TAZ-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F283C8-CC21-0D9C-58D8-F8C5A4C4A60F}"/>
              </a:ext>
            </a:extLst>
          </p:cNvPr>
          <p:cNvSpPr txBox="1"/>
          <p:nvPr/>
        </p:nvSpPr>
        <p:spPr>
          <a:xfrm>
            <a:off x="9774158" y="2378574"/>
            <a:ext cx="1309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TAZ-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1C35012-6A5E-1258-5434-1EEA6E4279E3}"/>
              </a:ext>
            </a:extLst>
          </p:cNvPr>
          <p:cNvSpPr txBox="1"/>
          <p:nvPr/>
        </p:nvSpPr>
        <p:spPr>
          <a:xfrm>
            <a:off x="7201733" y="2378574"/>
            <a:ext cx="1317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TAZ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9809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6010EAE-D1E4-D967-26AB-B96DB31BBD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956" y="137675"/>
            <a:ext cx="3600000" cy="3600000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4195B233-0483-C326-F47C-C8810C6DED30}"/>
              </a:ext>
            </a:extLst>
          </p:cNvPr>
          <p:cNvSpPr/>
          <p:nvPr/>
        </p:nvSpPr>
        <p:spPr>
          <a:xfrm>
            <a:off x="1989282" y="2045776"/>
            <a:ext cx="984143" cy="44170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CE9C331-BBDA-F05B-6CD4-DE533F255CA8}"/>
              </a:ext>
            </a:extLst>
          </p:cNvPr>
          <p:cNvSpPr txBox="1"/>
          <p:nvPr/>
        </p:nvSpPr>
        <p:spPr>
          <a:xfrm>
            <a:off x="909499" y="3993441"/>
            <a:ext cx="2159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A-GAPDH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ACD997F-10C5-60AD-073F-CD225A7C1B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9643" y="137673"/>
            <a:ext cx="2159566" cy="215956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D64DEFA-2040-D138-01FA-648B558D07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43713" y="137672"/>
            <a:ext cx="2159567" cy="2159567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C402A1A2-24B4-94A7-2E35-CE6B340723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5573" y="137673"/>
            <a:ext cx="2159566" cy="215956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D0DCFB0-6C72-1CD1-11D0-C2FAA9A67EC6}"/>
              </a:ext>
            </a:extLst>
          </p:cNvPr>
          <p:cNvSpPr txBox="1"/>
          <p:nvPr/>
        </p:nvSpPr>
        <p:spPr>
          <a:xfrm>
            <a:off x="6096000" y="3244334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0EBFF11-B15F-960C-7B3F-E3485969B128}"/>
              </a:ext>
            </a:extLst>
          </p:cNvPr>
          <p:cNvSpPr txBox="1"/>
          <p:nvPr/>
        </p:nvSpPr>
        <p:spPr>
          <a:xfrm>
            <a:off x="4843281" y="2378574"/>
            <a:ext cx="1584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GAPDH-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D205014-FE62-B703-AC12-7A09DC0DFD41}"/>
              </a:ext>
            </a:extLst>
          </p:cNvPr>
          <p:cNvSpPr txBox="1"/>
          <p:nvPr/>
        </p:nvSpPr>
        <p:spPr>
          <a:xfrm>
            <a:off x="9764325" y="2378574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GAPDH-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4BDC6A8-FE38-9F15-1524-5E68F5475435}"/>
              </a:ext>
            </a:extLst>
          </p:cNvPr>
          <p:cNvSpPr txBox="1"/>
          <p:nvPr/>
        </p:nvSpPr>
        <p:spPr>
          <a:xfrm>
            <a:off x="7303803" y="2392474"/>
            <a:ext cx="1584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-GAPDH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8848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6D45FD1-EC23-3E14-A3CB-5457C803C9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54" y="150174"/>
            <a:ext cx="3600000" cy="3600000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C37C3630-28AA-935B-ECB4-68EE6F17D1FF}"/>
              </a:ext>
            </a:extLst>
          </p:cNvPr>
          <p:cNvSpPr/>
          <p:nvPr/>
        </p:nvSpPr>
        <p:spPr>
          <a:xfrm>
            <a:off x="1844130" y="2190010"/>
            <a:ext cx="1301859" cy="44170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FBB435C-9C89-8301-1AF6-2B1361B91B12}"/>
              </a:ext>
            </a:extLst>
          </p:cNvPr>
          <p:cNvSpPr txBox="1"/>
          <p:nvPr/>
        </p:nvSpPr>
        <p:spPr>
          <a:xfrm>
            <a:off x="722503" y="3940073"/>
            <a:ext cx="2386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B-TAZ-A498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0C64A0C-1097-5CDA-3E71-849C6105E3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72813" y="150174"/>
            <a:ext cx="2386102" cy="23861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1F72DAE-0DF4-E5E6-B14A-EAC8F9D328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49796" y="150174"/>
            <a:ext cx="2386102" cy="2386102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C0C3B91C-1A27-F0E4-C98E-AB0DB8A2ED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1194" y="150174"/>
            <a:ext cx="2386102" cy="238610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46ACEEE-1EC9-3E50-7642-5FA6EBE73347}"/>
              </a:ext>
            </a:extLst>
          </p:cNvPr>
          <p:cNvSpPr txBox="1"/>
          <p:nvPr/>
        </p:nvSpPr>
        <p:spPr>
          <a:xfrm>
            <a:off x="5702710" y="3497472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E9EC5FE-7FB5-6B6B-F8F5-0F292B47BA5B}"/>
              </a:ext>
            </a:extLst>
          </p:cNvPr>
          <p:cNvSpPr txBox="1"/>
          <p:nvPr/>
        </p:nvSpPr>
        <p:spPr>
          <a:xfrm>
            <a:off x="4219393" y="2631712"/>
            <a:ext cx="172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A498-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1F9D543-3F80-E1C8-8EEA-DD4872057D45}"/>
              </a:ext>
            </a:extLst>
          </p:cNvPr>
          <p:cNvSpPr txBox="1"/>
          <p:nvPr/>
        </p:nvSpPr>
        <p:spPr>
          <a:xfrm>
            <a:off x="9371035" y="2631712"/>
            <a:ext cx="1718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A498-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697CC6E-5D37-6B3C-D5E7-159AF8714577}"/>
              </a:ext>
            </a:extLst>
          </p:cNvPr>
          <p:cNvSpPr txBox="1"/>
          <p:nvPr/>
        </p:nvSpPr>
        <p:spPr>
          <a:xfrm>
            <a:off x="6823304" y="2631712"/>
            <a:ext cx="172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A498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6130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83B5E88-C8B1-74C7-D126-206CD56487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932" y="131089"/>
            <a:ext cx="2994315" cy="2994315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105ADE3F-53E8-059A-DBAD-D8CB0455BEAC}"/>
              </a:ext>
            </a:extLst>
          </p:cNvPr>
          <p:cNvSpPr/>
          <p:nvPr/>
        </p:nvSpPr>
        <p:spPr>
          <a:xfrm>
            <a:off x="1732003" y="1538331"/>
            <a:ext cx="1069134" cy="36059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2804A6A-597B-C77B-3D88-BE3E7307F595}"/>
              </a:ext>
            </a:extLst>
          </p:cNvPr>
          <p:cNvSpPr txBox="1"/>
          <p:nvPr/>
        </p:nvSpPr>
        <p:spPr>
          <a:xfrm>
            <a:off x="519716" y="3369309"/>
            <a:ext cx="2424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B-TAZ-786-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BCC1927-7C14-927B-5066-D70108A90B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09394" y="131090"/>
            <a:ext cx="1619052" cy="161905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BD1A18E-4907-8CF3-CF34-4CC5BA7157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77164" y="131090"/>
            <a:ext cx="1619052" cy="161905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647F5B0-125C-17BC-1D3C-65D6742E54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4934" y="131090"/>
            <a:ext cx="1619052" cy="1619052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E31C7710-C82E-AA96-9452-5CEFCFAE97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41624" y="131089"/>
            <a:ext cx="1619053" cy="161905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B54B943-CC48-94BF-D17C-DA4742013C54}"/>
              </a:ext>
            </a:extLst>
          </p:cNvPr>
          <p:cNvSpPr txBox="1"/>
          <p:nvPr/>
        </p:nvSpPr>
        <p:spPr>
          <a:xfrm>
            <a:off x="5177164" y="3017881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E33AB97-B311-31F7-18E5-90ABA7A0790F}"/>
              </a:ext>
            </a:extLst>
          </p:cNvPr>
          <p:cNvSpPr txBox="1"/>
          <p:nvPr/>
        </p:nvSpPr>
        <p:spPr>
          <a:xfrm>
            <a:off x="3274347" y="1898930"/>
            <a:ext cx="1760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786-0-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AA2DC69-14DC-6A70-EF10-F2C27D814D62}"/>
              </a:ext>
            </a:extLst>
          </p:cNvPr>
          <p:cNvSpPr txBox="1"/>
          <p:nvPr/>
        </p:nvSpPr>
        <p:spPr>
          <a:xfrm>
            <a:off x="7009394" y="1898929"/>
            <a:ext cx="175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786-0-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DCE6C57-9091-AF09-C703-23C2AD8C6F28}"/>
              </a:ext>
            </a:extLst>
          </p:cNvPr>
          <p:cNvSpPr txBox="1"/>
          <p:nvPr/>
        </p:nvSpPr>
        <p:spPr>
          <a:xfrm>
            <a:off x="5167654" y="1898930"/>
            <a:ext cx="1760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786-0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CA3544B-3E2B-AF0E-643B-501B0D7A1A12}"/>
              </a:ext>
            </a:extLst>
          </p:cNvPr>
          <p:cNvSpPr txBox="1"/>
          <p:nvPr/>
        </p:nvSpPr>
        <p:spPr>
          <a:xfrm>
            <a:off x="8823719" y="1898929"/>
            <a:ext cx="1760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-TAZ-786-0-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4858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1D4E94A-69A2-8901-1232-87D835A093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84" y="101784"/>
            <a:ext cx="2290892" cy="2290892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DC773DB2-D768-AEDE-01B7-69D402A870CC}"/>
              </a:ext>
            </a:extLst>
          </p:cNvPr>
          <p:cNvSpPr/>
          <p:nvPr/>
        </p:nvSpPr>
        <p:spPr>
          <a:xfrm>
            <a:off x="438516" y="1477503"/>
            <a:ext cx="745418" cy="189064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D360D7D-5BDE-FDFB-6419-5BA6768BEF66}"/>
              </a:ext>
            </a:extLst>
          </p:cNvPr>
          <p:cNvSpPr txBox="1"/>
          <p:nvPr/>
        </p:nvSpPr>
        <p:spPr>
          <a:xfrm>
            <a:off x="81407" y="3042286"/>
            <a:ext cx="2826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B-GAPDH-786-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9FA8E53-B42E-7D9D-1A19-73B3605BD4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3119" y="101784"/>
            <a:ext cx="1606593" cy="160659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1B93F64-082C-D0ED-CD3E-9EEFE5C1A8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88218" y="101785"/>
            <a:ext cx="1606592" cy="160659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F0D489C-BEE1-C0BE-4111-F912B05739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8020" y="101784"/>
            <a:ext cx="1606593" cy="160659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CED0DEE-AA81-2BE3-629C-B804978066F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07822" y="101789"/>
            <a:ext cx="1606592" cy="1606592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875E2DD1-9AA7-EF0A-4B23-D9F3C1318A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921" y="101784"/>
            <a:ext cx="1606593" cy="160659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6B624E7-EFB8-EFAF-97BA-24AA8F8D5815}"/>
              </a:ext>
            </a:extLst>
          </p:cNvPr>
          <p:cNvSpPr txBox="1"/>
          <p:nvPr/>
        </p:nvSpPr>
        <p:spPr>
          <a:xfrm>
            <a:off x="5177164" y="3017881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17264F7-82C4-217B-02FB-D68B2FCD19DC}"/>
              </a:ext>
            </a:extLst>
          </p:cNvPr>
          <p:cNvSpPr txBox="1"/>
          <p:nvPr/>
        </p:nvSpPr>
        <p:spPr>
          <a:xfrm>
            <a:off x="2831005" y="1781397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786-0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F751453-CEDB-F2E9-0F22-6D87617375D5}"/>
              </a:ext>
            </a:extLst>
          </p:cNvPr>
          <p:cNvSpPr txBox="1"/>
          <p:nvPr/>
        </p:nvSpPr>
        <p:spPr>
          <a:xfrm>
            <a:off x="6330599" y="1751922"/>
            <a:ext cx="1712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786-0-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5612EBE-F19D-8161-00CD-819569F787B2}"/>
              </a:ext>
            </a:extLst>
          </p:cNvPr>
          <p:cNvSpPr txBox="1"/>
          <p:nvPr/>
        </p:nvSpPr>
        <p:spPr>
          <a:xfrm>
            <a:off x="4611859" y="1751922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786-0-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4D22F6-BFEC-BC48-9BFF-F44C71C11869}"/>
              </a:ext>
            </a:extLst>
          </p:cNvPr>
          <p:cNvSpPr txBox="1"/>
          <p:nvPr/>
        </p:nvSpPr>
        <p:spPr>
          <a:xfrm>
            <a:off x="8087045" y="1751921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786-0-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DFC5BBD-178A-100F-02D7-6E36E900697E}"/>
              </a:ext>
            </a:extLst>
          </p:cNvPr>
          <p:cNvSpPr txBox="1"/>
          <p:nvPr/>
        </p:nvSpPr>
        <p:spPr>
          <a:xfrm>
            <a:off x="9805785" y="1778446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786-0-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2095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1D4E94A-69A2-8901-1232-87D835A093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221" y="98347"/>
            <a:ext cx="2394005" cy="2394005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DC773DB2-D768-AEDE-01B7-69D402A870CC}"/>
              </a:ext>
            </a:extLst>
          </p:cNvPr>
          <p:cNvSpPr/>
          <p:nvPr/>
        </p:nvSpPr>
        <p:spPr>
          <a:xfrm>
            <a:off x="1174955" y="1519665"/>
            <a:ext cx="824512" cy="27384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72643BE-2068-5686-D978-420E7DB77307}"/>
              </a:ext>
            </a:extLst>
          </p:cNvPr>
          <p:cNvSpPr txBox="1"/>
          <p:nvPr/>
        </p:nvSpPr>
        <p:spPr>
          <a:xfrm>
            <a:off x="19855" y="3030160"/>
            <a:ext cx="2787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6B-GAPDH-A498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D9E71F03-8677-367D-6A96-BF1AE9E72E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3119" y="101784"/>
            <a:ext cx="1606593" cy="160659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D8B3B2B-2B50-8F10-20B1-B8FC70645B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88218" y="101785"/>
            <a:ext cx="1606592" cy="160659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AC38AE8-5E03-4103-2473-1E2BCFD0F6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8020" y="101784"/>
            <a:ext cx="1606593" cy="160659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9DD57FE-B46C-16CA-9A89-49D01DD6B9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07822" y="101789"/>
            <a:ext cx="1606592" cy="160659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5E78E65-4EA1-B072-86A4-91DCFD5BC3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921" y="101784"/>
            <a:ext cx="1606593" cy="1606593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52C3906A-CA88-D983-D748-304EFD898D5D}"/>
              </a:ext>
            </a:extLst>
          </p:cNvPr>
          <p:cNvSpPr txBox="1"/>
          <p:nvPr/>
        </p:nvSpPr>
        <p:spPr>
          <a:xfrm>
            <a:off x="5177164" y="3017881"/>
            <a:ext cx="396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Exposure images of different time 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D804E83-EEFB-036D-6120-3F1A412A980E}"/>
              </a:ext>
            </a:extLst>
          </p:cNvPr>
          <p:cNvSpPr txBox="1"/>
          <p:nvPr/>
        </p:nvSpPr>
        <p:spPr>
          <a:xfrm>
            <a:off x="2831005" y="1781397"/>
            <a:ext cx="16898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A498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3DB9008-A507-2387-FBB0-2C34BE6ECC6C}"/>
              </a:ext>
            </a:extLst>
          </p:cNvPr>
          <p:cNvSpPr txBox="1"/>
          <p:nvPr/>
        </p:nvSpPr>
        <p:spPr>
          <a:xfrm>
            <a:off x="6330599" y="1751922"/>
            <a:ext cx="16834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A498-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78A6B13-130C-8AC7-BA47-C550D1A25CE2}"/>
              </a:ext>
            </a:extLst>
          </p:cNvPr>
          <p:cNvSpPr txBox="1"/>
          <p:nvPr/>
        </p:nvSpPr>
        <p:spPr>
          <a:xfrm>
            <a:off x="4611859" y="1751922"/>
            <a:ext cx="16898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A498-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C1C3293-1A8A-66D8-C656-E4BA522756E7}"/>
              </a:ext>
            </a:extLst>
          </p:cNvPr>
          <p:cNvSpPr txBox="1"/>
          <p:nvPr/>
        </p:nvSpPr>
        <p:spPr>
          <a:xfrm>
            <a:off x="8087045" y="1751921"/>
            <a:ext cx="16898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A498-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E8BA2D0-153A-4D68-7B68-D1FB647BA044}"/>
              </a:ext>
            </a:extLst>
          </p:cNvPr>
          <p:cNvSpPr txBox="1"/>
          <p:nvPr/>
        </p:nvSpPr>
        <p:spPr>
          <a:xfrm>
            <a:off x="9805785" y="1778446"/>
            <a:ext cx="16898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6B-GAPDH-A498-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8434144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88</Words>
  <Application>Microsoft Office PowerPoint</Application>
  <PresentationFormat>宽屏</PresentationFormat>
  <Paragraphs>3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9" baseType="lpstr">
      <vt:lpstr>Arial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43022798</dc:creator>
  <cp:lastModifiedBy>振 何</cp:lastModifiedBy>
  <cp:revision>11</cp:revision>
  <dcterms:created xsi:type="dcterms:W3CDTF">2023-08-09T12:44:55Z</dcterms:created>
  <dcterms:modified xsi:type="dcterms:W3CDTF">2023-12-13T11:25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5259</vt:lpwstr>
  </property>
</Properties>
</file>